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11" userDrawn="1">
          <p15:clr>
            <a:srgbClr val="A4A3A4"/>
          </p15:clr>
        </p15:guide>
        <p15:guide id="2" pos="172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F7F7F"/>
    <a:srgbClr val="7D030A"/>
    <a:srgbClr val="020D7D"/>
    <a:srgbClr val="980B11"/>
    <a:srgbClr val="D70F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18"/>
    <p:restoredTop sz="95156"/>
  </p:normalViewPr>
  <p:slideViewPr>
    <p:cSldViewPr snapToGrid="0" snapToObjects="1" showGuides="1">
      <p:cViewPr varScale="1">
        <p:scale>
          <a:sx n="62" d="100"/>
          <a:sy n="62" d="100"/>
        </p:scale>
        <p:origin x="2856" y="200"/>
      </p:cViewPr>
      <p:guideLst>
        <p:guide orient="horz" pos="5411"/>
        <p:guide pos="172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220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58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104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811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771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860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402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547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927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297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038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52FC09-98E6-BE4D-B367-85110AAC8FF4}" type="datetimeFigureOut">
              <a:rPr lang="en-US" smtClean="0"/>
              <a:t>4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5215A-971B-0840-8EEF-B5134EC212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80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>
            <a:extLst>
              <a:ext uri="{FF2B5EF4-FFF2-40B4-BE49-F238E27FC236}">
                <a16:creationId xmlns:a16="http://schemas.microsoft.com/office/drawing/2014/main" id="{9F3941CC-C45B-5140-9DCD-212801FB8804}"/>
              </a:ext>
            </a:extLst>
          </p:cNvPr>
          <p:cNvSpPr txBox="1"/>
          <p:nvPr/>
        </p:nvSpPr>
        <p:spPr>
          <a:xfrm>
            <a:off x="950836" y="280436"/>
            <a:ext cx="319318" cy="3590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3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9F7250C-CE61-FE45-AAD2-E2D297C47D41}"/>
              </a:ext>
            </a:extLst>
          </p:cNvPr>
          <p:cNvSpPr txBox="1"/>
          <p:nvPr/>
        </p:nvSpPr>
        <p:spPr>
          <a:xfrm>
            <a:off x="953199" y="2734022"/>
            <a:ext cx="344966" cy="3590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E5CDB3D-15F9-D54F-8EC2-AA07BA249F17}"/>
              </a:ext>
            </a:extLst>
          </p:cNvPr>
          <p:cNvSpPr txBox="1"/>
          <p:nvPr/>
        </p:nvSpPr>
        <p:spPr>
          <a:xfrm>
            <a:off x="953199" y="5892271"/>
            <a:ext cx="344966" cy="3590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3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6D13C47-FD56-7941-B104-715C45FC2531}"/>
              </a:ext>
            </a:extLst>
          </p:cNvPr>
          <p:cNvSpPr txBox="1"/>
          <p:nvPr/>
        </p:nvSpPr>
        <p:spPr>
          <a:xfrm>
            <a:off x="2667064" y="333942"/>
            <a:ext cx="2715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platelet-COX-1-ko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3BDB1BE-F6EE-4443-A04D-4BC461056012}"/>
              </a:ext>
            </a:extLst>
          </p:cNvPr>
          <p:cNvSpPr txBox="1"/>
          <p:nvPr/>
        </p:nvSpPr>
        <p:spPr>
          <a:xfrm>
            <a:off x="2665684" y="2807201"/>
            <a:ext cx="4777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aspirin-treated control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6F9BCD0-8FF9-BC4D-87EA-E0CFC010ED1E}"/>
              </a:ext>
            </a:extLst>
          </p:cNvPr>
          <p:cNvSpPr txBox="1"/>
          <p:nvPr/>
        </p:nvSpPr>
        <p:spPr>
          <a:xfrm>
            <a:off x="2669355" y="5933794"/>
            <a:ext cx="2715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Arial" panose="020B0604020202020204" pitchFamily="34" charset="0"/>
              </a:rPr>
              <a:t>global-COX-1-k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C0EB91-1A7B-534E-8696-0FF6560636CB}"/>
              </a:ext>
            </a:extLst>
          </p:cNvPr>
          <p:cNvSpPr txBox="1"/>
          <p:nvPr/>
        </p:nvSpPr>
        <p:spPr>
          <a:xfrm>
            <a:off x="5147714" y="439059"/>
            <a:ext cx="32535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ecreased functio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9E056AF-9FEE-A743-B701-5C7D708115F0}"/>
              </a:ext>
            </a:extLst>
          </p:cNvPr>
          <p:cNvSpPr txBox="1"/>
          <p:nvPr/>
        </p:nvSpPr>
        <p:spPr>
          <a:xfrm>
            <a:off x="5146680" y="657637"/>
            <a:ext cx="32535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ncreased function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0C859FF-4D59-A947-9565-E7DFB18F90C1}"/>
              </a:ext>
            </a:extLst>
          </p:cNvPr>
          <p:cNvSpPr txBox="1"/>
          <p:nvPr/>
        </p:nvSpPr>
        <p:spPr>
          <a:xfrm>
            <a:off x="5149698" y="873359"/>
            <a:ext cx="32535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ffected functio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22C93C5-E420-9D44-A489-9620ABECB4FD}"/>
              </a:ext>
            </a:extLst>
          </p:cNvPr>
          <p:cNvSpPr/>
          <p:nvPr/>
        </p:nvSpPr>
        <p:spPr>
          <a:xfrm>
            <a:off x="4933103" y="527202"/>
            <a:ext cx="251999" cy="108000"/>
          </a:xfrm>
          <a:prstGeom prst="rect">
            <a:avLst/>
          </a:prstGeom>
          <a:solidFill>
            <a:srgbClr val="020D7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E6B8D72-354C-5C4C-943C-070DC36EE59B}"/>
              </a:ext>
            </a:extLst>
          </p:cNvPr>
          <p:cNvSpPr/>
          <p:nvPr/>
        </p:nvSpPr>
        <p:spPr>
          <a:xfrm>
            <a:off x="4938760" y="743730"/>
            <a:ext cx="251999" cy="108000"/>
          </a:xfrm>
          <a:prstGeom prst="rect">
            <a:avLst/>
          </a:prstGeom>
          <a:solidFill>
            <a:srgbClr val="7D030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81CAD9D-9D85-1B4C-80BE-242CDE074532}"/>
              </a:ext>
            </a:extLst>
          </p:cNvPr>
          <p:cNvSpPr/>
          <p:nvPr/>
        </p:nvSpPr>
        <p:spPr>
          <a:xfrm>
            <a:off x="4942693" y="959496"/>
            <a:ext cx="251999" cy="108000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ED051F7-F0C9-5845-BAB8-A0F5C57516D1}"/>
              </a:ext>
            </a:extLst>
          </p:cNvPr>
          <p:cNvSpPr txBox="1"/>
          <p:nvPr/>
        </p:nvSpPr>
        <p:spPr>
          <a:xfrm>
            <a:off x="1" y="8773235"/>
            <a:ext cx="6858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l Figure 3. Ingenuity Pathway Analysis (IPA) of influences of AA-derived COX eicosanoid production patterns on vascular function. </a:t>
            </a:r>
            <a:r>
              <a:rPr lang="en-US" sz="1100" dirty="0"/>
              <a:t>Bar charts illustrate up- and down-regulated diseases and functions related to vascular tone as predicted for (A) platelet-COX-1-ko mice, (B) aspirin-treated control mice and (C) global-COX-1-ko mice. Functions are ordered according to their -log significance, top ones are the most significant and bottom ones least significant. The dotted line represents the cut-off for significance set as p-value of 0.05. Blue, red and grey indicate diseases or functions that are predicted as decreased, increased or affected, respectively</a:t>
            </a:r>
            <a:r>
              <a:rPr lang="en-GB" sz="1100" dirty="0"/>
              <a:t>.</a:t>
            </a:r>
            <a:endParaRPr lang="en-US" sz="11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7D43FBE-FC4E-A442-9C22-AA82463A48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4139" y="586686"/>
            <a:ext cx="4399523" cy="19836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11CF226-BF32-3547-B639-96D1C3ECF8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014" y="3244953"/>
            <a:ext cx="5454822" cy="2394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8BD9AE5-3AC8-C944-8B58-F27A8FEF6A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014" y="6308061"/>
            <a:ext cx="5454822" cy="239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4746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</TotalTime>
  <Words>127</Words>
  <Application>Microsoft Macintosh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arilena Crescente</dc:creator>
  <cp:keywords/>
  <dc:description/>
  <cp:lastModifiedBy>Marilena Crescente</cp:lastModifiedBy>
  <cp:revision>29</cp:revision>
  <dcterms:created xsi:type="dcterms:W3CDTF">2019-06-25T08:28:03Z</dcterms:created>
  <dcterms:modified xsi:type="dcterms:W3CDTF">2020-04-20T14:24:26Z</dcterms:modified>
  <cp:category/>
</cp:coreProperties>
</file>